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212" y="-8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4C9E4C73-70CE-4CC4-94E8-241D51BF5274}" type="datetimeFigureOut">
              <a:rPr lang="en-US" smtClean="0"/>
              <a:t>5/2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64CECA4B-CE07-4DBA-B021-F1193E316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3454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87E5A4-CB4E-4D93-A214-077D3FFC39AC}" type="datetimeFigureOut">
              <a:rPr lang="en-GB" smtClean="0"/>
              <a:t>25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8D4F3-B1B1-4CDC-BD54-DEC46F03CFCE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Urozovski\Local Settings\Temporary Internet Files\Low\Content.IE5\QZR0JGR3\fig999[1]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56845" y="1679683"/>
            <a:ext cx="2741188" cy="20776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TextBox 46"/>
          <p:cNvSpPr txBox="1"/>
          <p:nvPr/>
        </p:nvSpPr>
        <p:spPr>
          <a:xfrm>
            <a:off x="1179623" y="5061756"/>
            <a:ext cx="3528683" cy="65308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b="1" dirty="0" smtClean="0"/>
              <a:t>Read genomic coordinates of STAT3 binding</a:t>
            </a:r>
          </a:p>
          <a:p>
            <a:endParaRPr lang="he-IL" dirty="0"/>
          </a:p>
        </p:txBody>
      </p:sp>
      <p:sp>
        <p:nvSpPr>
          <p:cNvPr id="5" name="TextBox 4"/>
          <p:cNvSpPr txBox="1"/>
          <p:nvPr/>
        </p:nvSpPr>
        <p:spPr>
          <a:xfrm>
            <a:off x="5292080" y="5061756"/>
            <a:ext cx="37334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Read </a:t>
            </a:r>
            <a:r>
              <a:rPr lang="en-US" sz="1600" b="1" dirty="0" err="1"/>
              <a:t>miR</a:t>
            </a:r>
            <a:r>
              <a:rPr lang="en-US" sz="1600" b="1" dirty="0"/>
              <a:t> </a:t>
            </a:r>
            <a:r>
              <a:rPr lang="en-US" sz="1600" b="1" dirty="0" smtClean="0"/>
              <a:t>promoter genomic coordinates</a:t>
            </a:r>
            <a:endParaRPr lang="en-US" sz="1600" b="1" dirty="0"/>
          </a:p>
        </p:txBody>
      </p:sp>
      <p:sp>
        <p:nvSpPr>
          <p:cNvPr id="128" name="חץ למטה 116"/>
          <p:cNvSpPr/>
          <p:nvPr/>
        </p:nvSpPr>
        <p:spPr>
          <a:xfrm>
            <a:off x="7010883" y="3766364"/>
            <a:ext cx="286477" cy="742756"/>
          </a:xfrm>
          <a:prstGeom prst="downArrow">
            <a:avLst/>
          </a:prstGeom>
          <a:noFill/>
          <a:ln w="222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034" name="TextBox 1033"/>
          <p:cNvSpPr txBox="1"/>
          <p:nvPr/>
        </p:nvSpPr>
        <p:spPr>
          <a:xfrm>
            <a:off x="1866327" y="6229288"/>
            <a:ext cx="66661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Genomic coordinates of STAT3 in </a:t>
            </a:r>
            <a:r>
              <a:rPr lang="en-US" sz="2000" b="1" dirty="0" err="1" smtClean="0"/>
              <a:t>miRs</a:t>
            </a:r>
            <a:r>
              <a:rPr lang="en-US" sz="2000" b="1" dirty="0" smtClean="0"/>
              <a:t> genes promoters</a:t>
            </a:r>
            <a:endParaRPr lang="en-US" sz="2000" b="1" dirty="0"/>
          </a:p>
        </p:txBody>
      </p:sp>
      <p:sp>
        <p:nvSpPr>
          <p:cNvPr id="1050" name="Multiply 1049"/>
          <p:cNvSpPr/>
          <p:nvPr/>
        </p:nvSpPr>
        <p:spPr>
          <a:xfrm>
            <a:off x="4829764" y="5267156"/>
            <a:ext cx="822356" cy="970156"/>
          </a:xfrm>
          <a:prstGeom prst="mathMultiply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20" name="Group 119"/>
          <p:cNvGrpSpPr/>
          <p:nvPr/>
        </p:nvGrpSpPr>
        <p:grpSpPr>
          <a:xfrm>
            <a:off x="437962" y="89705"/>
            <a:ext cx="5142150" cy="4939361"/>
            <a:chOff x="149930" y="89705"/>
            <a:chExt cx="5142150" cy="4939361"/>
          </a:xfrm>
        </p:grpSpPr>
        <p:sp>
          <p:nvSpPr>
            <p:cNvPr id="7" name="TextBox 6"/>
            <p:cNvSpPr txBox="1"/>
            <p:nvPr/>
          </p:nvSpPr>
          <p:spPr>
            <a:xfrm>
              <a:off x="257434" y="815081"/>
              <a:ext cx="256469" cy="29298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b="1" dirty="0" smtClean="0"/>
                <a:t>Cells</a:t>
              </a:r>
              <a:endParaRPr lang="he-IL" b="1" dirty="0"/>
            </a:p>
          </p:txBody>
        </p:sp>
        <p:pic>
          <p:nvPicPr>
            <p:cNvPr id="9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880573" y="2372747"/>
              <a:ext cx="163163" cy="202933"/>
            </a:xfrm>
            <a:prstGeom prst="rect">
              <a:avLst/>
            </a:prstGeom>
            <a:noFill/>
          </p:spPr>
        </p:pic>
        <p:pic>
          <p:nvPicPr>
            <p:cNvPr id="10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693108" y="2372747"/>
              <a:ext cx="163163" cy="202933"/>
            </a:xfrm>
            <a:prstGeom prst="rect">
              <a:avLst/>
            </a:prstGeom>
            <a:noFill/>
          </p:spPr>
        </p:pic>
        <p:pic>
          <p:nvPicPr>
            <p:cNvPr id="11" name="Picture 5" descr="C:\Users\CHAYON\Desktop\fig4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481343" y="2355475"/>
              <a:ext cx="172798" cy="204767"/>
            </a:xfrm>
            <a:prstGeom prst="rect">
              <a:avLst/>
            </a:prstGeom>
            <a:noFill/>
          </p:spPr>
        </p:pic>
        <p:sp>
          <p:nvSpPr>
            <p:cNvPr id="13" name="חץ למטה 120"/>
            <p:cNvSpPr/>
            <p:nvPr/>
          </p:nvSpPr>
          <p:spPr>
            <a:xfrm>
              <a:off x="1736630" y="4182794"/>
              <a:ext cx="104980" cy="241792"/>
            </a:xfrm>
            <a:prstGeom prst="downArrow">
              <a:avLst/>
            </a:prstGeom>
            <a:noFill/>
            <a:ln w="222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pic>
          <p:nvPicPr>
            <p:cNvPr id="111" name="Picture 3" descr="C:\Users\CHAYON\Desktop\fig2.pn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 rot="5581064">
              <a:off x="1584437" y="305451"/>
              <a:ext cx="399635" cy="782295"/>
            </a:xfrm>
            <a:prstGeom prst="rect">
              <a:avLst/>
            </a:prstGeom>
            <a:noFill/>
          </p:spPr>
        </p:pic>
        <p:pic>
          <p:nvPicPr>
            <p:cNvPr id="113" name="Picture 112" descr="http://seqcore.brcf.med.umich.edu/doc/educ/dnapr/reactions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679" t="24849" r="-1" b="14438"/>
            <a:stretch/>
          </p:blipFill>
          <p:spPr bwMode="auto">
            <a:xfrm rot="5595469">
              <a:off x="1599660" y="-21766"/>
              <a:ext cx="393612" cy="6920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4" name="Pie 3"/>
            <p:cNvSpPr/>
            <p:nvPr/>
          </p:nvSpPr>
          <p:spPr>
            <a:xfrm>
              <a:off x="1867562" y="150154"/>
              <a:ext cx="93732" cy="146284"/>
            </a:xfrm>
            <a:prstGeom prst="pie">
              <a:avLst>
                <a:gd name="adj1" fmla="val 0"/>
                <a:gd name="adj2" fmla="val 15275207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5" name="Pie 16"/>
            <p:cNvSpPr/>
            <p:nvPr/>
          </p:nvSpPr>
          <p:spPr>
            <a:xfrm>
              <a:off x="1680098" y="210602"/>
              <a:ext cx="93732" cy="146284"/>
            </a:xfrm>
            <a:prstGeom prst="pie">
              <a:avLst>
                <a:gd name="adj1" fmla="val 0"/>
                <a:gd name="adj2" fmla="val 15275207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6" name="Hexagon 4"/>
            <p:cNvSpPr/>
            <p:nvPr/>
          </p:nvSpPr>
          <p:spPr>
            <a:xfrm>
              <a:off x="1481342" y="573290"/>
              <a:ext cx="62488" cy="120896"/>
            </a:xfrm>
            <a:prstGeom prst="hexag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Hexagon 34"/>
            <p:cNvSpPr/>
            <p:nvPr/>
          </p:nvSpPr>
          <p:spPr>
            <a:xfrm>
              <a:off x="1617610" y="512842"/>
              <a:ext cx="54443" cy="126390"/>
            </a:xfrm>
            <a:prstGeom prst="hexagon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Pie 16"/>
            <p:cNvSpPr/>
            <p:nvPr/>
          </p:nvSpPr>
          <p:spPr>
            <a:xfrm>
              <a:off x="1992539" y="573290"/>
              <a:ext cx="93732" cy="146284"/>
            </a:xfrm>
            <a:prstGeom prst="pie">
              <a:avLst>
                <a:gd name="adj1" fmla="val 0"/>
                <a:gd name="adj2" fmla="val 15275207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9" name="Parallelogram 9"/>
            <p:cNvSpPr/>
            <p:nvPr/>
          </p:nvSpPr>
          <p:spPr>
            <a:xfrm>
              <a:off x="1805074" y="573290"/>
              <a:ext cx="54990" cy="151725"/>
            </a:xfrm>
            <a:prstGeom prst="parallelogram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7" name="Picture 5" descr="C:\Users\CHAYON\Desktop\fig4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043736" y="1628800"/>
              <a:ext cx="204043" cy="241791"/>
            </a:xfrm>
            <a:prstGeom prst="rect">
              <a:avLst/>
            </a:prstGeom>
            <a:noFill/>
          </p:spPr>
        </p:pic>
        <p:pic>
          <p:nvPicPr>
            <p:cNvPr id="19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755596" y="1689248"/>
              <a:ext cx="194407" cy="241792"/>
            </a:xfrm>
            <a:prstGeom prst="rect">
              <a:avLst/>
            </a:prstGeom>
            <a:noFill/>
          </p:spPr>
        </p:pic>
        <p:pic>
          <p:nvPicPr>
            <p:cNvPr id="21" name="Picture 5" descr="C:\Users\CHAYON\Desktop\fig4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777205" y="1419562"/>
              <a:ext cx="204043" cy="241791"/>
            </a:xfrm>
            <a:prstGeom prst="rect">
              <a:avLst/>
            </a:prstGeom>
            <a:noFill/>
          </p:spPr>
        </p:pic>
        <p:sp>
          <p:nvSpPr>
            <p:cNvPr id="23" name="Hexagon 34"/>
            <p:cNvSpPr/>
            <p:nvPr/>
          </p:nvSpPr>
          <p:spPr>
            <a:xfrm>
              <a:off x="2106224" y="1628800"/>
              <a:ext cx="54443" cy="126390"/>
            </a:xfrm>
            <a:prstGeom prst="hexagon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Pie 16"/>
            <p:cNvSpPr/>
            <p:nvPr/>
          </p:nvSpPr>
          <p:spPr>
            <a:xfrm>
              <a:off x="1825027" y="1454622"/>
              <a:ext cx="93732" cy="146284"/>
            </a:xfrm>
            <a:prstGeom prst="pie">
              <a:avLst>
                <a:gd name="adj1" fmla="val 0"/>
                <a:gd name="adj2" fmla="val 15275207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cxnSp>
          <p:nvCxnSpPr>
            <p:cNvPr id="108" name="מחבר חץ ישר 18"/>
            <p:cNvCxnSpPr/>
            <p:nvPr/>
          </p:nvCxnSpPr>
          <p:spPr>
            <a:xfrm>
              <a:off x="981438" y="452393"/>
              <a:ext cx="374929" cy="0"/>
            </a:xfrm>
            <a:prstGeom prst="straightConnector1">
              <a:avLst/>
            </a:prstGeom>
            <a:ln w="15875" cmpd="sng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מחבר חץ ישר 27"/>
            <p:cNvCxnSpPr/>
            <p:nvPr/>
          </p:nvCxnSpPr>
          <p:spPr>
            <a:xfrm>
              <a:off x="950194" y="452393"/>
              <a:ext cx="343685" cy="241792"/>
            </a:xfrm>
            <a:prstGeom prst="straightConnector1">
              <a:avLst/>
            </a:prstGeom>
            <a:ln w="15875" cmpd="sng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2273658" y="349825"/>
              <a:ext cx="2873290" cy="30777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b="1" dirty="0" smtClean="0">
                  <a:latin typeface="Calibri" pitchFamily="34" charset="0"/>
                </a:rPr>
                <a:t>Cross linking protein/DNA</a:t>
              </a:r>
              <a:endParaRPr lang="he-IL" sz="1400" b="1" dirty="0"/>
            </a:p>
          </p:txBody>
        </p:sp>
        <p:pic>
          <p:nvPicPr>
            <p:cNvPr id="97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536888" y="1238218"/>
              <a:ext cx="194407" cy="241792"/>
            </a:xfrm>
            <a:prstGeom prst="rect">
              <a:avLst/>
            </a:prstGeom>
            <a:noFill/>
          </p:spPr>
        </p:pic>
        <p:pic>
          <p:nvPicPr>
            <p:cNvPr id="98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036793" y="1419562"/>
              <a:ext cx="194407" cy="241792"/>
            </a:xfrm>
            <a:prstGeom prst="rect">
              <a:avLst/>
            </a:prstGeom>
            <a:noFill/>
          </p:spPr>
        </p:pic>
        <p:pic>
          <p:nvPicPr>
            <p:cNvPr id="99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411912" y="1419562"/>
              <a:ext cx="194407" cy="241792"/>
            </a:xfrm>
            <a:prstGeom prst="rect">
              <a:avLst/>
            </a:prstGeom>
            <a:noFill/>
          </p:spPr>
        </p:pic>
        <p:pic>
          <p:nvPicPr>
            <p:cNvPr id="100" name="Picture 5" descr="C:\Users\CHAYON\Desktop\fig4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808449" y="1177770"/>
              <a:ext cx="204043" cy="241791"/>
            </a:xfrm>
            <a:prstGeom prst="rect">
              <a:avLst/>
            </a:prstGeom>
            <a:noFill/>
          </p:spPr>
        </p:pic>
        <p:pic>
          <p:nvPicPr>
            <p:cNvPr id="101" name="Picture 5" descr="C:\Users\CHAYON\Desktop\fig4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371032" y="1628801"/>
              <a:ext cx="204043" cy="241791"/>
            </a:xfrm>
            <a:prstGeom prst="rect">
              <a:avLst/>
            </a:prstGeom>
            <a:noFill/>
          </p:spPr>
        </p:pic>
        <p:sp>
          <p:nvSpPr>
            <p:cNvPr id="102" name="Parallelogram 9"/>
            <p:cNvSpPr/>
            <p:nvPr/>
          </p:nvSpPr>
          <p:spPr>
            <a:xfrm>
              <a:off x="1613818" y="1267838"/>
              <a:ext cx="54990" cy="151725"/>
            </a:xfrm>
            <a:prstGeom prst="parallelogram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Hexagon 4"/>
            <p:cNvSpPr/>
            <p:nvPr/>
          </p:nvSpPr>
          <p:spPr>
            <a:xfrm>
              <a:off x="1450099" y="1689249"/>
              <a:ext cx="62488" cy="120896"/>
            </a:xfrm>
            <a:prstGeom prst="hexag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2273658" y="1404066"/>
              <a:ext cx="3018422" cy="584775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b="1" dirty="0" smtClean="0"/>
                <a:t>Shear DNA strands  by </a:t>
              </a:r>
              <a:r>
                <a:rPr lang="en-US" sz="1400" b="1" dirty="0" err="1" smtClean="0"/>
                <a:t>sonification</a:t>
              </a:r>
              <a:endParaRPr lang="en-US" sz="1400" b="1" dirty="0" smtClean="0"/>
            </a:p>
            <a:p>
              <a:r>
                <a:rPr lang="en-US" b="1" dirty="0" smtClean="0"/>
                <a:t> </a:t>
              </a:r>
              <a:endParaRPr lang="en-US" sz="1400" b="1" dirty="0" smtClean="0"/>
            </a:p>
          </p:txBody>
        </p:sp>
        <p:sp>
          <p:nvSpPr>
            <p:cNvPr id="105" name="חץ למטה 54"/>
            <p:cNvSpPr/>
            <p:nvPr/>
          </p:nvSpPr>
          <p:spPr>
            <a:xfrm>
              <a:off x="1731295" y="935978"/>
              <a:ext cx="104980" cy="241792"/>
            </a:xfrm>
            <a:prstGeom prst="downArrow">
              <a:avLst/>
            </a:prstGeom>
            <a:noFill/>
            <a:ln w="222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8" name="חץ למטה 55"/>
            <p:cNvSpPr/>
            <p:nvPr/>
          </p:nvSpPr>
          <p:spPr>
            <a:xfrm>
              <a:off x="1736630" y="2024043"/>
              <a:ext cx="104980" cy="241792"/>
            </a:xfrm>
            <a:prstGeom prst="downArrow">
              <a:avLst/>
            </a:prstGeom>
            <a:noFill/>
            <a:ln w="222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273658" y="2276872"/>
              <a:ext cx="2971815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b="1" dirty="0" err="1" smtClean="0"/>
                <a:t>Immunopeecipitation</a:t>
              </a:r>
              <a:r>
                <a:rPr lang="en-US" sz="1400" b="1" dirty="0" smtClean="0"/>
                <a:t> with bead attached anti-STAT3 antibodies </a:t>
              </a:r>
            </a:p>
          </p:txBody>
        </p:sp>
        <p:pic>
          <p:nvPicPr>
            <p:cNvPr id="30" name="Picture 5" descr="C:\Users\CHAYON\Desktop\fig4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887516" y="3295718"/>
              <a:ext cx="156220" cy="185122"/>
            </a:xfrm>
            <a:prstGeom prst="rect">
              <a:avLst/>
            </a:prstGeom>
            <a:noFill/>
          </p:spPr>
        </p:pic>
        <p:pic>
          <p:nvPicPr>
            <p:cNvPr id="31" name="Picture 5" descr="C:\Users\CHAYON\Desktop\fig4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18760" y="3094729"/>
              <a:ext cx="172798" cy="204767"/>
            </a:xfrm>
            <a:prstGeom prst="rect">
              <a:avLst/>
            </a:prstGeom>
            <a:noFill/>
          </p:spPr>
        </p:pic>
        <p:pic>
          <p:nvPicPr>
            <p:cNvPr id="32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130525" y="3157012"/>
              <a:ext cx="163163" cy="202933"/>
            </a:xfrm>
            <a:prstGeom prst="rect">
              <a:avLst/>
            </a:prstGeom>
            <a:noFill/>
          </p:spPr>
        </p:pic>
        <p:pic>
          <p:nvPicPr>
            <p:cNvPr id="33" name="Picture 4" descr="C:\Users\CHAYON\Desktop\fig3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054150" y="3299496"/>
              <a:ext cx="145806" cy="181344"/>
            </a:xfrm>
            <a:prstGeom prst="rect">
              <a:avLst/>
            </a:prstGeom>
            <a:noFill/>
          </p:spPr>
        </p:pic>
        <p:grpSp>
          <p:nvGrpSpPr>
            <p:cNvPr id="88" name="Group 91"/>
            <p:cNvGrpSpPr/>
            <p:nvPr/>
          </p:nvGrpSpPr>
          <p:grpSpPr>
            <a:xfrm rot="11411132">
              <a:off x="1532268" y="3185907"/>
              <a:ext cx="93406" cy="180780"/>
              <a:chOff x="4572004" y="3048003"/>
              <a:chExt cx="457195" cy="914398"/>
            </a:xfrm>
          </p:grpSpPr>
          <p:sp>
            <p:nvSpPr>
              <p:cNvPr id="90" name="Hexagon 93"/>
              <p:cNvSpPr/>
              <p:nvPr/>
            </p:nvSpPr>
            <p:spPr>
              <a:xfrm>
                <a:off x="4648200" y="3429001"/>
                <a:ext cx="380999" cy="533400"/>
              </a:xfrm>
              <a:prstGeom prst="hexagon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91" name="Group 94"/>
              <p:cNvGrpSpPr/>
              <p:nvPr/>
            </p:nvGrpSpPr>
            <p:grpSpPr>
              <a:xfrm>
                <a:off x="4572004" y="3048003"/>
                <a:ext cx="361949" cy="657030"/>
                <a:chOff x="4571996" y="2733868"/>
                <a:chExt cx="361942" cy="657032"/>
              </a:xfrm>
            </p:grpSpPr>
            <p:grpSp>
              <p:nvGrpSpPr>
                <p:cNvPr id="92" name="Group 95"/>
                <p:cNvGrpSpPr/>
                <p:nvPr/>
              </p:nvGrpSpPr>
              <p:grpSpPr>
                <a:xfrm>
                  <a:off x="4648190" y="3124202"/>
                  <a:ext cx="285748" cy="266698"/>
                  <a:chOff x="4648188" y="677918"/>
                  <a:chExt cx="285763" cy="2751081"/>
                </a:xfrm>
              </p:grpSpPr>
              <p:cxnSp>
                <p:nvCxnSpPr>
                  <p:cNvPr id="94" name="Straight Connector 97"/>
                  <p:cNvCxnSpPr>
                    <a:stCxn id="90" idx="4"/>
                    <a:endCxn id="90" idx="3"/>
                  </p:cNvCxnSpPr>
                  <p:nvPr/>
                </p:nvCxnSpPr>
                <p:spPr>
                  <a:xfrm flipH="1">
                    <a:off x="4648188" y="677918"/>
                    <a:ext cx="95251" cy="52727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Straight Connector 98"/>
                  <p:cNvCxnSpPr>
                    <a:stCxn id="90" idx="4"/>
                    <a:endCxn id="90" idx="5"/>
                  </p:cNvCxnSpPr>
                  <p:nvPr/>
                </p:nvCxnSpPr>
                <p:spPr>
                  <a:xfrm>
                    <a:off x="4743453" y="3428999"/>
                    <a:ext cx="19049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93" name="Straight Connector 96"/>
                <p:cNvCxnSpPr/>
                <p:nvPr/>
              </p:nvCxnSpPr>
              <p:spPr>
                <a:xfrm flipH="1" flipV="1">
                  <a:off x="4571996" y="2733868"/>
                  <a:ext cx="171452" cy="390333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89" name="Oval 92"/>
            <p:cNvSpPr/>
            <p:nvPr/>
          </p:nvSpPr>
          <p:spPr>
            <a:xfrm rot="11411132">
              <a:off x="1575038" y="3359505"/>
              <a:ext cx="67120" cy="105201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0" name="Group 79"/>
            <p:cNvGrpSpPr/>
            <p:nvPr/>
          </p:nvGrpSpPr>
          <p:grpSpPr>
            <a:xfrm rot="11411132">
              <a:off x="1407292" y="3185907"/>
              <a:ext cx="93406" cy="180780"/>
              <a:chOff x="4572004" y="3048003"/>
              <a:chExt cx="457195" cy="914398"/>
            </a:xfrm>
          </p:grpSpPr>
          <p:sp>
            <p:nvSpPr>
              <p:cNvPr id="82" name="Hexagon 81"/>
              <p:cNvSpPr/>
              <p:nvPr/>
            </p:nvSpPr>
            <p:spPr>
              <a:xfrm>
                <a:off x="4648200" y="3429001"/>
                <a:ext cx="380999" cy="533400"/>
              </a:xfrm>
              <a:prstGeom prst="hexagon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83" name="Group 82"/>
              <p:cNvGrpSpPr/>
              <p:nvPr/>
            </p:nvGrpSpPr>
            <p:grpSpPr>
              <a:xfrm>
                <a:off x="4572004" y="3048003"/>
                <a:ext cx="361949" cy="657030"/>
                <a:chOff x="4571996" y="2733868"/>
                <a:chExt cx="361942" cy="657032"/>
              </a:xfrm>
            </p:grpSpPr>
            <p:grpSp>
              <p:nvGrpSpPr>
                <p:cNvPr id="84" name="Group 83"/>
                <p:cNvGrpSpPr/>
                <p:nvPr/>
              </p:nvGrpSpPr>
              <p:grpSpPr>
                <a:xfrm>
                  <a:off x="4648190" y="3124202"/>
                  <a:ext cx="285748" cy="266698"/>
                  <a:chOff x="4648188" y="677918"/>
                  <a:chExt cx="285763" cy="2751081"/>
                </a:xfrm>
              </p:grpSpPr>
              <p:cxnSp>
                <p:nvCxnSpPr>
                  <p:cNvPr id="86" name="Straight Connector 85"/>
                  <p:cNvCxnSpPr>
                    <a:stCxn id="82" idx="4"/>
                    <a:endCxn id="82" idx="3"/>
                  </p:cNvCxnSpPr>
                  <p:nvPr/>
                </p:nvCxnSpPr>
                <p:spPr>
                  <a:xfrm flipH="1">
                    <a:off x="4648188" y="677918"/>
                    <a:ext cx="95251" cy="52727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7" name="Straight Connector 86"/>
                  <p:cNvCxnSpPr>
                    <a:stCxn id="82" idx="4"/>
                    <a:endCxn id="82" idx="5"/>
                  </p:cNvCxnSpPr>
                  <p:nvPr/>
                </p:nvCxnSpPr>
                <p:spPr>
                  <a:xfrm>
                    <a:off x="4743453" y="3428999"/>
                    <a:ext cx="19049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85" name="Straight Connector 84"/>
                <p:cNvCxnSpPr/>
                <p:nvPr/>
              </p:nvCxnSpPr>
              <p:spPr>
                <a:xfrm flipH="1" flipV="1">
                  <a:off x="4571996" y="2733868"/>
                  <a:ext cx="171452" cy="390333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81" name="Oval 80"/>
            <p:cNvSpPr/>
            <p:nvPr/>
          </p:nvSpPr>
          <p:spPr>
            <a:xfrm rot="11411132">
              <a:off x="1450062" y="3359505"/>
              <a:ext cx="67120" cy="105201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72" name="Group 91"/>
            <p:cNvGrpSpPr/>
            <p:nvPr/>
          </p:nvGrpSpPr>
          <p:grpSpPr>
            <a:xfrm rot="11411132">
              <a:off x="1657244" y="3185907"/>
              <a:ext cx="93406" cy="180780"/>
              <a:chOff x="4572004" y="3048003"/>
              <a:chExt cx="457195" cy="914398"/>
            </a:xfrm>
          </p:grpSpPr>
          <p:sp>
            <p:nvSpPr>
              <p:cNvPr id="74" name="Hexagon 93"/>
              <p:cNvSpPr/>
              <p:nvPr/>
            </p:nvSpPr>
            <p:spPr>
              <a:xfrm>
                <a:off x="4648200" y="3429001"/>
                <a:ext cx="380999" cy="533400"/>
              </a:xfrm>
              <a:prstGeom prst="hexagon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75" name="Group 94"/>
              <p:cNvGrpSpPr/>
              <p:nvPr/>
            </p:nvGrpSpPr>
            <p:grpSpPr>
              <a:xfrm>
                <a:off x="4572004" y="3048003"/>
                <a:ext cx="361949" cy="657030"/>
                <a:chOff x="4571996" y="2733868"/>
                <a:chExt cx="361942" cy="657032"/>
              </a:xfrm>
            </p:grpSpPr>
            <p:grpSp>
              <p:nvGrpSpPr>
                <p:cNvPr id="76" name="Group 95"/>
                <p:cNvGrpSpPr/>
                <p:nvPr/>
              </p:nvGrpSpPr>
              <p:grpSpPr>
                <a:xfrm>
                  <a:off x="4648190" y="3124202"/>
                  <a:ext cx="285748" cy="266698"/>
                  <a:chOff x="4648188" y="677918"/>
                  <a:chExt cx="285763" cy="2751081"/>
                </a:xfrm>
              </p:grpSpPr>
              <p:cxnSp>
                <p:nvCxnSpPr>
                  <p:cNvPr id="78" name="Straight Connector 97"/>
                  <p:cNvCxnSpPr>
                    <a:stCxn id="74" idx="4"/>
                    <a:endCxn id="74" idx="3"/>
                  </p:cNvCxnSpPr>
                  <p:nvPr/>
                </p:nvCxnSpPr>
                <p:spPr>
                  <a:xfrm flipH="1">
                    <a:off x="4648188" y="677918"/>
                    <a:ext cx="95251" cy="52727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9" name="Straight Connector 98"/>
                  <p:cNvCxnSpPr>
                    <a:stCxn id="74" idx="4"/>
                    <a:endCxn id="74" idx="5"/>
                  </p:cNvCxnSpPr>
                  <p:nvPr/>
                </p:nvCxnSpPr>
                <p:spPr>
                  <a:xfrm>
                    <a:off x="4743453" y="3428999"/>
                    <a:ext cx="19049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7" name="Straight Connector 96"/>
                <p:cNvCxnSpPr/>
                <p:nvPr/>
              </p:nvCxnSpPr>
              <p:spPr>
                <a:xfrm flipH="1" flipV="1">
                  <a:off x="4571996" y="2733868"/>
                  <a:ext cx="171452" cy="390333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3" name="Oval 92"/>
            <p:cNvSpPr/>
            <p:nvPr/>
          </p:nvSpPr>
          <p:spPr>
            <a:xfrm rot="11411132">
              <a:off x="1700014" y="3359505"/>
              <a:ext cx="67120" cy="105201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חץ למטה 108"/>
            <p:cNvSpPr/>
            <p:nvPr/>
          </p:nvSpPr>
          <p:spPr>
            <a:xfrm>
              <a:off x="1736630" y="2852936"/>
              <a:ext cx="104980" cy="241792"/>
            </a:xfrm>
            <a:prstGeom prst="downArrow">
              <a:avLst/>
            </a:prstGeom>
            <a:noFill/>
            <a:ln w="222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273658" y="3094729"/>
              <a:ext cx="1529778" cy="584775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400" b="1" dirty="0" smtClean="0"/>
                <a:t>Reverse </a:t>
              </a:r>
              <a:r>
                <a:rPr lang="en-US" sz="1400" b="1" dirty="0" err="1" smtClean="0"/>
                <a:t>crosslinks</a:t>
              </a:r>
              <a:endParaRPr lang="en-US" sz="1400" b="1" dirty="0" smtClean="0"/>
            </a:p>
            <a:p>
              <a:endParaRPr lang="he-IL" b="1" dirty="0"/>
            </a:p>
          </p:txBody>
        </p:sp>
        <p:grpSp>
          <p:nvGrpSpPr>
            <p:cNvPr id="64" name="Group 91"/>
            <p:cNvGrpSpPr/>
            <p:nvPr/>
          </p:nvGrpSpPr>
          <p:grpSpPr>
            <a:xfrm rot="11411132">
              <a:off x="1938518" y="2412196"/>
              <a:ext cx="93406" cy="180780"/>
              <a:chOff x="4572004" y="3048003"/>
              <a:chExt cx="457195" cy="914398"/>
            </a:xfrm>
          </p:grpSpPr>
          <p:sp>
            <p:nvSpPr>
              <p:cNvPr id="66" name="Hexagon 93"/>
              <p:cNvSpPr/>
              <p:nvPr/>
            </p:nvSpPr>
            <p:spPr>
              <a:xfrm>
                <a:off x="4648200" y="3429001"/>
                <a:ext cx="380999" cy="533400"/>
              </a:xfrm>
              <a:prstGeom prst="hexagon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67" name="Group 94"/>
              <p:cNvGrpSpPr/>
              <p:nvPr/>
            </p:nvGrpSpPr>
            <p:grpSpPr>
              <a:xfrm>
                <a:off x="4572004" y="3048003"/>
                <a:ext cx="361949" cy="657030"/>
                <a:chOff x="4571996" y="2733868"/>
                <a:chExt cx="361942" cy="657032"/>
              </a:xfrm>
            </p:grpSpPr>
            <p:grpSp>
              <p:nvGrpSpPr>
                <p:cNvPr id="68" name="Group 95"/>
                <p:cNvGrpSpPr/>
                <p:nvPr/>
              </p:nvGrpSpPr>
              <p:grpSpPr>
                <a:xfrm>
                  <a:off x="4648190" y="3124202"/>
                  <a:ext cx="285748" cy="266698"/>
                  <a:chOff x="4648188" y="677918"/>
                  <a:chExt cx="285763" cy="2751081"/>
                </a:xfrm>
              </p:grpSpPr>
              <p:cxnSp>
                <p:nvCxnSpPr>
                  <p:cNvPr id="70" name="Straight Connector 97"/>
                  <p:cNvCxnSpPr>
                    <a:stCxn id="66" idx="4"/>
                    <a:endCxn id="66" idx="3"/>
                  </p:cNvCxnSpPr>
                  <p:nvPr/>
                </p:nvCxnSpPr>
                <p:spPr>
                  <a:xfrm flipH="1">
                    <a:off x="4648188" y="677918"/>
                    <a:ext cx="95251" cy="52727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Straight Connector 98"/>
                  <p:cNvCxnSpPr>
                    <a:stCxn id="66" idx="4"/>
                    <a:endCxn id="66" idx="5"/>
                  </p:cNvCxnSpPr>
                  <p:nvPr/>
                </p:nvCxnSpPr>
                <p:spPr>
                  <a:xfrm>
                    <a:off x="4743453" y="3428999"/>
                    <a:ext cx="19049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9" name="Straight Connector 96"/>
                <p:cNvCxnSpPr/>
                <p:nvPr/>
              </p:nvCxnSpPr>
              <p:spPr>
                <a:xfrm flipH="1" flipV="1">
                  <a:off x="4571996" y="2733868"/>
                  <a:ext cx="171452" cy="390333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5" name="Oval 92"/>
            <p:cNvSpPr/>
            <p:nvPr/>
          </p:nvSpPr>
          <p:spPr>
            <a:xfrm rot="11411132">
              <a:off x="1981288" y="2585794"/>
              <a:ext cx="67120" cy="105201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6" name="Group 91"/>
            <p:cNvGrpSpPr/>
            <p:nvPr/>
          </p:nvGrpSpPr>
          <p:grpSpPr>
            <a:xfrm rot="11411132">
              <a:off x="1751053" y="2412196"/>
              <a:ext cx="93406" cy="180780"/>
              <a:chOff x="4572004" y="3048003"/>
              <a:chExt cx="457195" cy="914398"/>
            </a:xfrm>
          </p:grpSpPr>
          <p:sp>
            <p:nvSpPr>
              <p:cNvPr id="58" name="Hexagon 93"/>
              <p:cNvSpPr/>
              <p:nvPr/>
            </p:nvSpPr>
            <p:spPr>
              <a:xfrm>
                <a:off x="4648200" y="3429001"/>
                <a:ext cx="380999" cy="533400"/>
              </a:xfrm>
              <a:prstGeom prst="hexagon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59" name="Group 94"/>
              <p:cNvGrpSpPr/>
              <p:nvPr/>
            </p:nvGrpSpPr>
            <p:grpSpPr>
              <a:xfrm>
                <a:off x="4572004" y="3048003"/>
                <a:ext cx="361949" cy="657030"/>
                <a:chOff x="4571996" y="2733868"/>
                <a:chExt cx="361942" cy="657032"/>
              </a:xfrm>
            </p:grpSpPr>
            <p:grpSp>
              <p:nvGrpSpPr>
                <p:cNvPr id="60" name="Group 95"/>
                <p:cNvGrpSpPr/>
                <p:nvPr/>
              </p:nvGrpSpPr>
              <p:grpSpPr>
                <a:xfrm>
                  <a:off x="4648190" y="3124202"/>
                  <a:ext cx="285748" cy="266698"/>
                  <a:chOff x="4648188" y="677918"/>
                  <a:chExt cx="285763" cy="2751081"/>
                </a:xfrm>
              </p:grpSpPr>
              <p:cxnSp>
                <p:nvCxnSpPr>
                  <p:cNvPr id="62" name="Straight Connector 97"/>
                  <p:cNvCxnSpPr>
                    <a:stCxn id="58" idx="4"/>
                    <a:endCxn id="58" idx="3"/>
                  </p:cNvCxnSpPr>
                  <p:nvPr/>
                </p:nvCxnSpPr>
                <p:spPr>
                  <a:xfrm flipH="1">
                    <a:off x="4648188" y="677918"/>
                    <a:ext cx="95251" cy="52727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Straight Connector 98"/>
                  <p:cNvCxnSpPr>
                    <a:stCxn id="58" idx="4"/>
                    <a:endCxn id="58" idx="5"/>
                  </p:cNvCxnSpPr>
                  <p:nvPr/>
                </p:nvCxnSpPr>
                <p:spPr>
                  <a:xfrm>
                    <a:off x="4743453" y="3428999"/>
                    <a:ext cx="19049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1" name="Straight Connector 96"/>
                <p:cNvCxnSpPr/>
                <p:nvPr/>
              </p:nvCxnSpPr>
              <p:spPr>
                <a:xfrm flipH="1" flipV="1">
                  <a:off x="4571996" y="2733868"/>
                  <a:ext cx="171452" cy="390333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7" name="Oval 92"/>
            <p:cNvSpPr/>
            <p:nvPr/>
          </p:nvSpPr>
          <p:spPr>
            <a:xfrm rot="11411132">
              <a:off x="1793823" y="2585794"/>
              <a:ext cx="67120" cy="105201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8" name="Group 91"/>
            <p:cNvGrpSpPr/>
            <p:nvPr/>
          </p:nvGrpSpPr>
          <p:grpSpPr>
            <a:xfrm rot="11411132">
              <a:off x="1532268" y="2423231"/>
              <a:ext cx="93406" cy="180780"/>
              <a:chOff x="4572004" y="3048003"/>
              <a:chExt cx="457195" cy="914398"/>
            </a:xfrm>
          </p:grpSpPr>
          <p:sp>
            <p:nvSpPr>
              <p:cNvPr id="50" name="Hexagon 93"/>
              <p:cNvSpPr/>
              <p:nvPr/>
            </p:nvSpPr>
            <p:spPr>
              <a:xfrm>
                <a:off x="4648200" y="3429001"/>
                <a:ext cx="380999" cy="533400"/>
              </a:xfrm>
              <a:prstGeom prst="hexagon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51" name="Group 94"/>
              <p:cNvGrpSpPr/>
              <p:nvPr/>
            </p:nvGrpSpPr>
            <p:grpSpPr>
              <a:xfrm>
                <a:off x="4572004" y="3048003"/>
                <a:ext cx="361949" cy="657030"/>
                <a:chOff x="4571996" y="2733868"/>
                <a:chExt cx="361942" cy="657032"/>
              </a:xfrm>
            </p:grpSpPr>
            <p:grpSp>
              <p:nvGrpSpPr>
                <p:cNvPr id="52" name="Group 95"/>
                <p:cNvGrpSpPr/>
                <p:nvPr/>
              </p:nvGrpSpPr>
              <p:grpSpPr>
                <a:xfrm>
                  <a:off x="4648190" y="3124202"/>
                  <a:ext cx="285748" cy="266698"/>
                  <a:chOff x="4648188" y="677918"/>
                  <a:chExt cx="285763" cy="2751081"/>
                </a:xfrm>
              </p:grpSpPr>
              <p:cxnSp>
                <p:nvCxnSpPr>
                  <p:cNvPr id="54" name="Straight Connector 97"/>
                  <p:cNvCxnSpPr>
                    <a:stCxn id="50" idx="4"/>
                    <a:endCxn id="50" idx="3"/>
                  </p:cNvCxnSpPr>
                  <p:nvPr/>
                </p:nvCxnSpPr>
                <p:spPr>
                  <a:xfrm flipH="1">
                    <a:off x="4648188" y="677918"/>
                    <a:ext cx="95251" cy="52727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Straight Connector 98"/>
                  <p:cNvCxnSpPr>
                    <a:stCxn id="50" idx="4"/>
                    <a:endCxn id="50" idx="5"/>
                  </p:cNvCxnSpPr>
                  <p:nvPr/>
                </p:nvCxnSpPr>
                <p:spPr>
                  <a:xfrm>
                    <a:off x="4743453" y="3428999"/>
                    <a:ext cx="19049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53" name="Straight Connector 96"/>
                <p:cNvCxnSpPr/>
                <p:nvPr/>
              </p:nvCxnSpPr>
              <p:spPr>
                <a:xfrm flipH="1" flipV="1">
                  <a:off x="4571996" y="2733868"/>
                  <a:ext cx="171452" cy="390333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9" name="Oval 92"/>
            <p:cNvSpPr/>
            <p:nvPr/>
          </p:nvSpPr>
          <p:spPr>
            <a:xfrm rot="11411132">
              <a:off x="1575038" y="2596829"/>
              <a:ext cx="67120" cy="105201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2" name="Picture 6" descr="C:\Users\CHAYON\Desktop\fig5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481343" y="3880553"/>
              <a:ext cx="635296" cy="312315"/>
            </a:xfrm>
            <a:prstGeom prst="rect">
              <a:avLst/>
            </a:prstGeom>
            <a:noFill/>
          </p:spPr>
        </p:pic>
        <p:sp>
          <p:nvSpPr>
            <p:cNvPr id="43" name="חץ למטה 116"/>
            <p:cNvSpPr/>
            <p:nvPr/>
          </p:nvSpPr>
          <p:spPr>
            <a:xfrm>
              <a:off x="1736630" y="3638761"/>
              <a:ext cx="104980" cy="241792"/>
            </a:xfrm>
            <a:prstGeom prst="downArrow">
              <a:avLst/>
            </a:prstGeom>
            <a:noFill/>
            <a:ln w="222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44" name="מלבן 117"/>
            <p:cNvSpPr/>
            <p:nvPr/>
          </p:nvSpPr>
          <p:spPr>
            <a:xfrm>
              <a:off x="2273658" y="3829360"/>
              <a:ext cx="90281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/>
                <a:t>Sequence</a:t>
              </a:r>
              <a:endParaRPr lang="en-US" sz="1400" b="1" dirty="0"/>
            </a:p>
          </p:txBody>
        </p:sp>
        <p:pic>
          <p:nvPicPr>
            <p:cNvPr id="45" name="Picture 7" descr="C:\Users\CHAYON\Desktop\fig6.pn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481343" y="4495108"/>
              <a:ext cx="682162" cy="533958"/>
            </a:xfrm>
            <a:prstGeom prst="rect">
              <a:avLst/>
            </a:prstGeom>
            <a:noFill/>
          </p:spPr>
        </p:pic>
        <p:sp>
          <p:nvSpPr>
            <p:cNvPr id="46" name="TextBox 45"/>
            <p:cNvSpPr txBox="1"/>
            <p:nvPr/>
          </p:nvSpPr>
          <p:spPr>
            <a:xfrm>
              <a:off x="2273658" y="4455896"/>
              <a:ext cx="1442574" cy="52322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400" b="1" dirty="0" smtClean="0"/>
                <a:t>Align to genome </a:t>
              </a:r>
            </a:p>
            <a:p>
              <a:endParaRPr lang="he-IL" sz="1400" b="1" dirty="0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149930" y="89705"/>
              <a:ext cx="888199" cy="653715"/>
              <a:chOff x="362847" y="89705"/>
              <a:chExt cx="525352" cy="653715"/>
            </a:xfrm>
          </p:grpSpPr>
          <p:pic>
            <p:nvPicPr>
              <p:cNvPr id="106" name="Picture 2" descr="C:\Users\CHAYON\Desktop\cells.png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62847" y="89705"/>
                <a:ext cx="311139" cy="601962"/>
              </a:xfrm>
              <a:prstGeom prst="rect">
                <a:avLst/>
              </a:prstGeom>
              <a:noFill/>
            </p:spPr>
          </p:pic>
          <p:pic>
            <p:nvPicPr>
              <p:cNvPr id="107" name="Picture 2" descr="C:\Users\CHAYON\Desktop\cells.png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 rot="20942126">
                <a:off x="577060" y="141458"/>
                <a:ext cx="311139" cy="601962"/>
              </a:xfrm>
              <a:prstGeom prst="rect">
                <a:avLst/>
              </a:prstGeom>
              <a:noFill/>
            </p:spPr>
          </p:pic>
        </p:grpSp>
      </p:grpSp>
      <p:sp>
        <p:nvSpPr>
          <p:cNvPr id="121" name="TextBox 120"/>
          <p:cNvSpPr txBox="1"/>
          <p:nvPr/>
        </p:nvSpPr>
        <p:spPr>
          <a:xfrm rot="16200000">
            <a:off x="-388971" y="6028870"/>
            <a:ext cx="11689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1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4170932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1</TotalTime>
  <Words>43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oshiba</dc:creator>
  <cp:lastModifiedBy>Rozovski,Uri</cp:lastModifiedBy>
  <cp:revision>25</cp:revision>
  <cp:lastPrinted>2013-04-29T04:06:06Z</cp:lastPrinted>
  <dcterms:created xsi:type="dcterms:W3CDTF">2012-11-08T09:28:51Z</dcterms:created>
  <dcterms:modified xsi:type="dcterms:W3CDTF">2013-05-26T03:43:24Z</dcterms:modified>
</cp:coreProperties>
</file>